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75" d="100"/>
          <a:sy n="75" d="100"/>
        </p:scale>
        <p:origin x="51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FA92DD7-65D6-4B68-AA9C-DA96604AF319}" type="datetimeFigureOut">
              <a:rPr lang="zh-CN" altLang="en-US" smtClean="0"/>
              <a:t>2019/5/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4DAF80C-ACF9-45D1-8814-D82517DBC6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019036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3DDBDD1-DA2D-4B57-8889-A9BDE56AD2E9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15532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F32F2-3488-45BB-9965-B27FF8FAB685}" type="datetimeFigureOut">
              <a:rPr lang="zh-CN" altLang="en-US" smtClean="0"/>
              <a:t>2019/5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EB75A-688F-44BC-8CFF-D24680F4E1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17334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F32F2-3488-45BB-9965-B27FF8FAB685}" type="datetimeFigureOut">
              <a:rPr lang="zh-CN" altLang="en-US" smtClean="0"/>
              <a:t>2019/5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EB75A-688F-44BC-8CFF-D24680F4E1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658353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F32F2-3488-45BB-9965-B27FF8FAB685}" type="datetimeFigureOut">
              <a:rPr lang="zh-CN" altLang="en-US" smtClean="0"/>
              <a:t>2019/5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EB75A-688F-44BC-8CFF-D24680F4E1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993503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F32F2-3488-45BB-9965-B27FF8FAB685}" type="datetimeFigureOut">
              <a:rPr lang="zh-CN" altLang="en-US" smtClean="0"/>
              <a:t>2019/5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EB75A-688F-44BC-8CFF-D24680F4E1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22618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F32F2-3488-45BB-9965-B27FF8FAB685}" type="datetimeFigureOut">
              <a:rPr lang="zh-CN" altLang="en-US" smtClean="0"/>
              <a:t>2019/5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EB75A-688F-44BC-8CFF-D24680F4E1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63160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F32F2-3488-45BB-9965-B27FF8FAB685}" type="datetimeFigureOut">
              <a:rPr lang="zh-CN" altLang="en-US" smtClean="0"/>
              <a:t>2019/5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EB75A-688F-44BC-8CFF-D24680F4E1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72795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F32F2-3488-45BB-9965-B27FF8FAB685}" type="datetimeFigureOut">
              <a:rPr lang="zh-CN" altLang="en-US" smtClean="0"/>
              <a:t>2019/5/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EB75A-688F-44BC-8CFF-D24680F4E1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460995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F32F2-3488-45BB-9965-B27FF8FAB685}" type="datetimeFigureOut">
              <a:rPr lang="zh-CN" altLang="en-US" smtClean="0"/>
              <a:t>2019/5/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EB75A-688F-44BC-8CFF-D24680F4E1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8765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F32F2-3488-45BB-9965-B27FF8FAB685}" type="datetimeFigureOut">
              <a:rPr lang="zh-CN" altLang="en-US" smtClean="0"/>
              <a:t>2019/5/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EB75A-688F-44BC-8CFF-D24680F4E1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1220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F32F2-3488-45BB-9965-B27FF8FAB685}" type="datetimeFigureOut">
              <a:rPr lang="zh-CN" altLang="en-US" smtClean="0"/>
              <a:t>2019/5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EB75A-688F-44BC-8CFF-D24680F4E1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55481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F32F2-3488-45BB-9965-B27FF8FAB685}" type="datetimeFigureOut">
              <a:rPr lang="zh-CN" altLang="en-US" smtClean="0"/>
              <a:t>2019/5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EB75A-688F-44BC-8CFF-D24680F4E1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72684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EF32F2-3488-45BB-9965-B27FF8FAB685}" type="datetimeFigureOut">
              <a:rPr lang="zh-CN" altLang="en-US" smtClean="0"/>
              <a:t>2019/5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AEB75A-688F-44BC-8CFF-D24680F4E1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76804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直接连接符 4"/>
          <p:cNvCxnSpPr/>
          <p:nvPr/>
        </p:nvCxnSpPr>
        <p:spPr>
          <a:xfrm>
            <a:off x="1808782" y="5897846"/>
            <a:ext cx="848571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Rectangle 2"/>
          <p:cNvSpPr>
            <a:spLocks noChangeArrowheads="1"/>
          </p:cNvSpPr>
          <p:nvPr/>
        </p:nvSpPr>
        <p:spPr bwMode="auto">
          <a:xfrm>
            <a:off x="4395109" y="2084605"/>
            <a:ext cx="68765" cy="13745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34018" tIns="17009" rIns="34018" bIns="17009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 sz="670"/>
          </a:p>
        </p:txBody>
      </p:sp>
      <p:graphicFrame>
        <p:nvGraphicFramePr>
          <p:cNvPr id="7" name="对象 6"/>
          <p:cNvGraphicFramePr>
            <a:graphicFrameLocks noChangeAspect="1"/>
          </p:cNvGraphicFramePr>
          <p:nvPr>
            <p:extLst/>
          </p:nvPr>
        </p:nvGraphicFramePr>
        <p:xfrm>
          <a:off x="2444166" y="446383"/>
          <a:ext cx="7811854" cy="514285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Visio" r:id="rId4" imgW="7445410" imgH="4900764" progId="Visio.Drawing.11">
                  <p:embed/>
                </p:oleObj>
              </mc:Choice>
              <mc:Fallback>
                <p:oleObj name="Visio" r:id="rId4" imgW="7445410" imgH="4900764" progId="Visio.Drawing.11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444166" y="446383"/>
                        <a:ext cx="7811854" cy="5142857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1808782" y="6148795"/>
            <a:ext cx="8485714" cy="4440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43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mmarize the flow for determination of tissue-specific and tissue-conserved existent microRNAs in soybean through construction and analysis of their networks. Mission parts in red and yellow generated confident results. </a:t>
            </a:r>
            <a:endParaRPr lang="zh-CN" altLang="en-US" sz="114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标题 1"/>
          <p:cNvSpPr>
            <a:spLocks noGrp="1"/>
          </p:cNvSpPr>
          <p:nvPr>
            <p:ph type="title" idx="4294967295"/>
          </p:nvPr>
        </p:nvSpPr>
        <p:spPr>
          <a:xfrm>
            <a:off x="1808782" y="5840188"/>
            <a:ext cx="6425306" cy="425224"/>
          </a:xfrm>
        </p:spPr>
        <p:txBody>
          <a:bodyPr>
            <a:noAutofit/>
          </a:bodyPr>
          <a:lstStyle/>
          <a:p>
            <a:r>
              <a:rPr lang="en-US" altLang="zh-CN" sz="114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43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 </a:t>
            </a:r>
            <a:r>
              <a:rPr lang="en-US" altLang="zh-CN" sz="114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workflow of microRNA regulatory networks.</a:t>
            </a:r>
            <a:endParaRPr lang="zh-CN" altLang="en-US" sz="114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19621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2</Words>
  <Application>Microsoft Office PowerPoint</Application>
  <PresentationFormat>宽屏</PresentationFormat>
  <Paragraphs>3</Paragraphs>
  <Slides>1</Slides>
  <Notes>1</Notes>
  <HiddenSlides>0</HiddenSlides>
  <MMClips>0</MMClips>
  <ScaleCrop>false</ScaleCrop>
  <HeadingPairs>
    <vt:vector size="8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宋体</vt:lpstr>
      <vt:lpstr>Arial</vt:lpstr>
      <vt:lpstr>Calibri</vt:lpstr>
      <vt:lpstr>Calibri Light</vt:lpstr>
      <vt:lpstr>Times New Roman</vt:lpstr>
      <vt:lpstr>Office 主题</vt:lpstr>
      <vt:lpstr>Visio</vt:lpstr>
      <vt:lpstr> Figure S1 Analysis workflow of microRNA regulatory networks.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 Figure S1 Analysis workflow of microRNA regulatory networks.</dc:title>
  <dc:creator>Windows 用户</dc:creator>
  <cp:lastModifiedBy>Windows 用户</cp:lastModifiedBy>
  <cp:revision>1</cp:revision>
  <dcterms:created xsi:type="dcterms:W3CDTF">2019-05-07T16:02:42Z</dcterms:created>
  <dcterms:modified xsi:type="dcterms:W3CDTF">2019-05-07T16:03:51Z</dcterms:modified>
</cp:coreProperties>
</file>